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BCB0A0-8DC0-4C25-9AE0-E815AF6C76B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5D2755-E62F-4EEA-BDA4-E2D9A30A24D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156075-3CC1-4295-AD5B-B58000086CC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BED411-9209-46CF-8C66-2A3BA4493E1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3620BA-C690-4022-B2AC-BDB4E5A16A9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F6484D-5437-4F29-BCB1-B6A0E77725B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BF18F4-5BE7-48E4-91C2-35CA9EBA531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279728-6AEC-497C-9393-8D7FA54D820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039F0C-FFD7-4614-BD13-6D84DE4400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A4112A-F11A-47C0-86CF-B35F46D23F9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C70D2F-190C-4396-8B93-50095466120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5DC04C-E404-4E8C-8E2F-E57979BB4A1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E07D776-2D49-49D4-A06B-E6A08F7D51F6}" type="slidenum">
              <a:rPr b="0" lang="en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1" descr=""/>
          <p:cNvPicPr/>
          <p:nvPr/>
        </p:nvPicPr>
        <p:blipFill>
          <a:blip r:embed="rId1"/>
          <a:stretch/>
        </p:blipFill>
        <p:spPr>
          <a:xfrm>
            <a:off x="333360" y="576360"/>
            <a:ext cx="2162160" cy="2160360"/>
          </a:xfrm>
          <a:prstGeom prst="rect">
            <a:avLst/>
          </a:prstGeom>
          <a:ln w="0">
            <a:noFill/>
          </a:ln>
        </p:spPr>
      </p:pic>
      <p:grpSp>
        <p:nvGrpSpPr>
          <p:cNvPr id="42" name="Group 7"/>
          <p:cNvGrpSpPr/>
          <p:nvPr/>
        </p:nvGrpSpPr>
        <p:grpSpPr>
          <a:xfrm>
            <a:off x="2565360" y="576360"/>
            <a:ext cx="2162160" cy="2160720"/>
            <a:chOff x="2565360" y="576360"/>
            <a:chExt cx="2162160" cy="2160720"/>
          </a:xfrm>
        </p:grpSpPr>
        <p:pic>
          <p:nvPicPr>
            <p:cNvPr id="43" name="Picture 4" descr=""/>
            <p:cNvPicPr/>
            <p:nvPr/>
          </p:nvPicPr>
          <p:blipFill>
            <a:blip r:embed="rId2"/>
            <a:stretch/>
          </p:blipFill>
          <p:spPr>
            <a:xfrm>
              <a:off x="2565360" y="576360"/>
              <a:ext cx="2162160" cy="2160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TextBox 31"/>
            <p:cNvSpPr/>
            <p:nvPr/>
          </p:nvSpPr>
          <p:spPr>
            <a:xfrm>
              <a:off x="3827160" y="2490840"/>
              <a:ext cx="900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CA" sz="1000" spc="-1" strike="noStrike">
                  <a:solidFill>
                    <a:srgbClr val="3ced33"/>
                  </a:solidFill>
                  <a:latin typeface="Arial"/>
                  <a:ea typeface="Arial"/>
                </a:rPr>
                <a:t>FMRP</a:t>
              </a:r>
              <a:r>
                <a:rPr b="1" lang="en-CA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/</a:t>
              </a:r>
              <a:r>
                <a:rPr b="1" lang="en-CA" sz="1000" spc="-1" strike="noStrike">
                  <a:solidFill>
                    <a:srgbClr val="383892"/>
                  </a:solidFill>
                  <a:latin typeface="Arial"/>
                  <a:ea typeface="Arial"/>
                </a:rPr>
                <a:t>DAP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5" name="TextBox 31"/>
          <p:cNvSpPr/>
          <p:nvPr/>
        </p:nvSpPr>
        <p:spPr>
          <a:xfrm>
            <a:off x="1200240" y="298440"/>
            <a:ext cx="428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W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31"/>
          <p:cNvSpPr/>
          <p:nvPr/>
        </p:nvSpPr>
        <p:spPr>
          <a:xfrm>
            <a:off x="3252960" y="298440"/>
            <a:ext cx="788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mr1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K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7" name="Group 3"/>
          <p:cNvGrpSpPr/>
          <p:nvPr/>
        </p:nvGrpSpPr>
        <p:grpSpPr>
          <a:xfrm>
            <a:off x="333000" y="3294000"/>
            <a:ext cx="5328000" cy="482760"/>
            <a:chOff x="333000" y="3294000"/>
            <a:chExt cx="5328000" cy="482760"/>
          </a:xfrm>
        </p:grpSpPr>
        <p:pic>
          <p:nvPicPr>
            <p:cNvPr id="48" name="Picture 1" descr=""/>
            <p:cNvPicPr/>
            <p:nvPr/>
          </p:nvPicPr>
          <p:blipFill>
            <a:blip r:embed="rId3"/>
            <a:stretch/>
          </p:blipFill>
          <p:spPr>
            <a:xfrm flipH="1">
              <a:off x="333000" y="3294000"/>
              <a:ext cx="4393800" cy="482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9" name="TextBox 15"/>
            <p:cNvSpPr/>
            <p:nvPr/>
          </p:nvSpPr>
          <p:spPr>
            <a:xfrm>
              <a:off x="4510080" y="3381480"/>
              <a:ext cx="115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FMRP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0" name="Group 4"/>
          <p:cNvGrpSpPr/>
          <p:nvPr/>
        </p:nvGrpSpPr>
        <p:grpSpPr>
          <a:xfrm>
            <a:off x="401760" y="3863880"/>
            <a:ext cx="5259240" cy="492120"/>
            <a:chOff x="401760" y="3863880"/>
            <a:chExt cx="5259240" cy="492120"/>
          </a:xfrm>
        </p:grpSpPr>
        <p:pic>
          <p:nvPicPr>
            <p:cNvPr id="51" name="Picture 2" descr=""/>
            <p:cNvPicPr/>
            <p:nvPr/>
          </p:nvPicPr>
          <p:blipFill>
            <a:blip r:embed="rId4"/>
            <a:stretch/>
          </p:blipFill>
          <p:spPr>
            <a:xfrm>
              <a:off x="401760" y="3863880"/>
              <a:ext cx="4325760" cy="492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2" name="TextBox 15"/>
            <p:cNvSpPr/>
            <p:nvPr/>
          </p:nvSpPr>
          <p:spPr>
            <a:xfrm>
              <a:off x="4510080" y="3955680"/>
              <a:ext cx="115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GAPDH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3" name="Text Box 24"/>
          <p:cNvSpPr/>
          <p:nvPr/>
        </p:nvSpPr>
        <p:spPr>
          <a:xfrm>
            <a:off x="1123920" y="2927520"/>
            <a:ext cx="584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W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26"/>
          <p:cNvSpPr/>
          <p:nvPr/>
        </p:nvSpPr>
        <p:spPr>
          <a:xfrm>
            <a:off x="401760" y="3205080"/>
            <a:ext cx="209376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31"/>
          <p:cNvSpPr/>
          <p:nvPr/>
        </p:nvSpPr>
        <p:spPr>
          <a:xfrm>
            <a:off x="3252960" y="2927520"/>
            <a:ext cx="788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mr1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K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26"/>
          <p:cNvSpPr/>
          <p:nvPr/>
        </p:nvSpPr>
        <p:spPr>
          <a:xfrm>
            <a:off x="2565360" y="3203640"/>
            <a:ext cx="209556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31"/>
          <p:cNvSpPr/>
          <p:nvPr/>
        </p:nvSpPr>
        <p:spPr>
          <a:xfrm>
            <a:off x="333360" y="299880"/>
            <a:ext cx="276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31"/>
          <p:cNvSpPr/>
          <p:nvPr/>
        </p:nvSpPr>
        <p:spPr>
          <a:xfrm>
            <a:off x="331920" y="2874960"/>
            <a:ext cx="276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31"/>
          <p:cNvSpPr/>
          <p:nvPr/>
        </p:nvSpPr>
        <p:spPr>
          <a:xfrm>
            <a:off x="549360" y="4716360"/>
            <a:ext cx="583236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. 1. Absence of FMRP in primary astrocytes derived from 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mr1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KO mice. (a)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mmunocytochemistry on primary mouse astrocyte cultures labeling FMRP confirmed the absence of FMRP in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mr1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KO astrocytes. Scale bar: 20</a:t>
            </a:r>
            <a:r>
              <a:rPr b="0" lang="el-G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μ</a:t>
            </a:r>
            <a:r>
              <a:rPr b="0" lang="en-CA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. </a:t>
            </a:r>
            <a:r>
              <a:rPr b="1" lang="en-CA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b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estern blot analysis further verified the loss of FMRP expression within the KO group. Experiments were performed in duplicate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31"/>
          <p:cNvSpPr/>
          <p:nvPr/>
        </p:nvSpPr>
        <p:spPr>
          <a:xfrm>
            <a:off x="3816360" y="8675640"/>
            <a:ext cx="3041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Straight Connector 21"/>
          <p:cNvSpPr/>
          <p:nvPr/>
        </p:nvSpPr>
        <p:spPr>
          <a:xfrm>
            <a:off x="2708280" y="2627280"/>
            <a:ext cx="450720" cy="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10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1-24T18:37:19Z</dcterms:created>
  <dc:creator>Frankie</dc:creator>
  <dc:description/>
  <dc:language>en-US</dc:language>
  <cp:lastModifiedBy>Frankie</cp:lastModifiedBy>
  <dcterms:modified xsi:type="dcterms:W3CDTF">2019-04-09T20:49:25Z</dcterms:modified>
  <cp:revision>312</cp:revision>
  <dc:subject/>
  <dc:title>Slide 1</dc:title>
</cp:coreProperties>
</file>